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FF2600"/>
    <a:srgbClr val="73F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15"/>
    <p:restoredTop sz="94637"/>
  </p:normalViewPr>
  <p:slideViewPr>
    <p:cSldViewPr snapToGrid="0" snapToObjects="1">
      <p:cViewPr varScale="1">
        <p:scale>
          <a:sx n="72" d="100"/>
          <a:sy n="72" d="100"/>
        </p:scale>
        <p:origin x="5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A3D307-269C-984D-A1D2-52936F998F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B1AF535-F3B6-1141-BEB8-55A60C51B5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46E097-25CC-DC4D-BC54-D85C0FB82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B514C9-3A17-7340-B692-7F5BAC2B8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172FC6-7EE6-0242-BB04-67527F8F3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896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95E2B3-8BC5-E74B-BAAF-9C860A2D2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690C341-905F-1D44-B878-3A2E462EAE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2EF610-7FA4-194A-9502-6ED7636D2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032D85-67CF-DA4F-8C04-D7B3F2B4C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CC7A90-36A6-D148-8AEC-C06BC67B3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958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08152F4-78C8-C745-B0B3-727B78D942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C477B50-B8A4-0D4A-AB08-744BD2EB91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C08B7D-E030-BC45-AE71-542B8DAD9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7515EE-07D9-9F41-915F-95D787008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E08033-D02E-C54F-8DAD-4B207FB08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191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603210-4C08-6146-B131-E46B59678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87FA24F-BC80-6D40-A200-DB1C55718E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B02BD0-B03E-6843-9BDF-470D330BD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CC9C2D-F738-DF47-908D-CF6172812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496086-D9B7-F745-8751-C50FF734A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555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DF8ABB-8904-CE40-824D-AAB36851C2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D287A1-C19D-0F4B-8CDC-69E9657151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BD92DD-2479-B545-A28E-4ADB209CC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5B55DA-EFDF-8A42-B130-06DCBC89E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5EBD90-2ED5-6E4B-B05B-81E8AA916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307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CE5F6C-6FD4-0E40-9220-B181450B27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30BD49-79FE-FD46-9F78-172983E19B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BE4D10B-6E4B-274C-A7DA-DA93122383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4BFD09-E325-3C4B-8DC9-BC4BAE028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0A8058D-77D6-9043-9292-8B79738A4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135EA5-D35B-B94E-A09F-2553776CE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5599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0F27D2-1E96-3742-BC03-66FEA3451A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B6DE0B-44FE-4543-A2E7-763AECD5F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24C201-0578-974B-90B7-9DECFAACA3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2E60F21-5ECF-6E47-B909-016E2865BA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06B9C1E-AA45-524F-BAD5-019D2D6618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7B2DFAB-13C7-DE44-9341-37C3A9DD7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7F7B45-C2BD-7642-8EE0-523740200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EF8942C-8665-1D4C-B01D-0D7816B08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9148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957A53-8BFF-E843-AE8D-9DBB8D5113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1C848CF-65A5-F445-8944-1A270BDF6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4C5264-D71A-8144-88E2-A0403D247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8106233-2EF7-AD4C-B766-8AF85D13E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487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1D9B126-F9CC-1B41-B389-27372BD17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12222B9-42DC-A14F-BE7D-4E57C5094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D58E1E0-E621-8049-B957-1778D4C0D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264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C62940-526C-C54F-93E9-CF542606B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4542BE-9D21-BB42-A61A-B9B883D0B4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0201F57-04EC-064C-95EE-3C4F062B53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62D425-3C9F-1344-A56B-E6F02DDFD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7698D7-5C06-0E43-9A9A-D7E3DEBB5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60D623-FF96-D942-9CF8-8E79EAFA5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8803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7FAFAF-0980-1743-AF2A-5A175AB14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7AD1791-B568-BA4E-8DC2-E5FCFBEDDD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886163-B0A9-444F-B636-DC1177ADE6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5D97AF5-5B7E-6A4F-AB09-5A32E9146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287EE8-96B6-9A4D-B6E7-904205402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8788107-1E9C-6144-832B-7368EAA23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159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02232A3-4388-5045-929E-8A4E55213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D5D317-5ADC-9C4D-852A-5EDD098CBD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428E2F-584F-A941-A65C-896ECF0F7C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EC945-09FB-F64C-96CE-688B7021D209}" type="datetimeFigureOut">
              <a:rPr kumimoji="1" lang="ja-JP" altLang="en-US" smtClean="0"/>
              <a:t>2021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480D49-33C8-4445-9800-81ED0617C3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7D3913-59AD-384A-A6E7-9D60D91E2E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3A841-7996-8A47-A4F3-04119832E4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681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4.wdp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12" Type="http://schemas.openxmlformats.org/officeDocument/2006/relationships/image" Target="../media/image8.png"/><Relationship Id="rId17" Type="http://schemas.microsoft.com/office/2007/relationships/hdphoto" Target="../media/hdphoto6.wdp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microsoft.com/office/2007/relationships/hdphoto" Target="../media/hdphoto3.wdp"/><Relationship Id="rId5" Type="http://schemas.openxmlformats.org/officeDocument/2006/relationships/image" Target="../media/image4.png"/><Relationship Id="rId15" Type="http://schemas.microsoft.com/office/2007/relationships/hdphoto" Target="../media/hdphoto5.wdp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microsoft.com/office/2007/relationships/hdphoto" Target="../media/hdphoto2.wdp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 descr="屋外, 雪, 飛ぶ, 鳥 が含まれている画像&#10;&#10;自動的に生成された説明">
            <a:extLst>
              <a:ext uri="{FF2B5EF4-FFF2-40B4-BE49-F238E27FC236}">
                <a16:creationId xmlns:a16="http://schemas.microsoft.com/office/drawing/2014/main" id="{2FD9621B-1113-1E40-AE98-388C2522731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37869" y="1989000"/>
            <a:ext cx="1800000" cy="144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図 14" descr="食品, 持つ, 飛ぶ, 大きい が含まれている画像&#10;&#10;自動的に生成された説明">
            <a:extLst>
              <a:ext uri="{FF2B5EF4-FFF2-40B4-BE49-F238E27FC236}">
                <a16:creationId xmlns:a16="http://schemas.microsoft.com/office/drawing/2014/main" id="{6347C986-5C94-C64A-866F-1F3700FC512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27"/>
          <a:stretch/>
        </p:blipFill>
        <p:spPr>
          <a:xfrm>
            <a:off x="3437869" y="3561944"/>
            <a:ext cx="1800000" cy="146308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図 16" descr="食品, テーブル, 座る, 大きい が含まれている画像&#10;&#10;自動的に生成された説明">
            <a:extLst>
              <a:ext uri="{FF2B5EF4-FFF2-40B4-BE49-F238E27FC236}">
                <a16:creationId xmlns:a16="http://schemas.microsoft.com/office/drawing/2014/main" id="{4EC9C4FE-0EB8-3C44-9775-797B48D7432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6670" y="3561944"/>
            <a:ext cx="1800000" cy="1440001"/>
          </a:xfrm>
          <a:prstGeom prst="rect">
            <a:avLst/>
          </a:prstGeom>
        </p:spPr>
      </p:pic>
      <p:pic>
        <p:nvPicPr>
          <p:cNvPr id="19" name="図 18" descr="雪が積もった地面&#10;&#10;中程度の精度で自動的に生成された説明">
            <a:extLst>
              <a:ext uri="{FF2B5EF4-FFF2-40B4-BE49-F238E27FC236}">
                <a16:creationId xmlns:a16="http://schemas.microsoft.com/office/drawing/2014/main" id="{5DB0BA0A-C10C-7247-B267-8D6127801D3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6670" y="1989000"/>
            <a:ext cx="1800000" cy="144000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074AA06-6618-364D-998B-4AB0DE78AD14}"/>
              </a:ext>
            </a:extLst>
          </p:cNvPr>
          <p:cNvSpPr txBox="1"/>
          <p:nvPr/>
        </p:nvSpPr>
        <p:spPr>
          <a:xfrm>
            <a:off x="2158192" y="2121944"/>
            <a:ext cx="900000" cy="720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14D5DF0-AC7E-A84C-9F61-90E6DF673F69}"/>
              </a:ext>
            </a:extLst>
          </p:cNvPr>
          <p:cNvSpPr txBox="1"/>
          <p:nvPr/>
        </p:nvSpPr>
        <p:spPr>
          <a:xfrm>
            <a:off x="2137610" y="3676303"/>
            <a:ext cx="900000" cy="720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1126B294-EEB8-B24A-A913-1F7671E990C5}"/>
              </a:ext>
            </a:extLst>
          </p:cNvPr>
          <p:cNvCxnSpPr>
            <a:cxnSpLocks/>
          </p:cNvCxnSpPr>
          <p:nvPr/>
        </p:nvCxnSpPr>
        <p:spPr>
          <a:xfrm>
            <a:off x="3058193" y="2587487"/>
            <a:ext cx="360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3313C5A3-B6A7-B044-AAA8-E1756E44CAED}"/>
              </a:ext>
            </a:extLst>
          </p:cNvPr>
          <p:cNvCxnSpPr>
            <a:cxnSpLocks/>
          </p:cNvCxnSpPr>
          <p:nvPr/>
        </p:nvCxnSpPr>
        <p:spPr>
          <a:xfrm>
            <a:off x="3037611" y="4171122"/>
            <a:ext cx="396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86D09CB-0D5A-EE45-9515-4132FBED48A6}"/>
              </a:ext>
            </a:extLst>
          </p:cNvPr>
          <p:cNvSpPr txBox="1"/>
          <p:nvPr/>
        </p:nvSpPr>
        <p:spPr>
          <a:xfrm>
            <a:off x="2292417" y="1494458"/>
            <a:ext cx="21788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 Peritoneum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718557F-86ED-B44F-A8F3-01F62BB062E8}"/>
              </a:ext>
            </a:extLst>
          </p:cNvPr>
          <p:cNvSpPr txBox="1"/>
          <p:nvPr/>
        </p:nvSpPr>
        <p:spPr>
          <a:xfrm>
            <a:off x="823980" y="4097278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&amp;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3FEE8CF-2C24-AB4D-B406-D1B1ED6C4B89}"/>
              </a:ext>
            </a:extLst>
          </p:cNvPr>
          <p:cNvSpPr txBox="1"/>
          <p:nvPr/>
        </p:nvSpPr>
        <p:spPr>
          <a:xfrm>
            <a:off x="823980" y="2524334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CE138D48-BC9A-B243-B082-97B30E32B90A}"/>
              </a:ext>
            </a:extLst>
          </p:cNvPr>
          <p:cNvCxnSpPr>
            <a:cxnSpLocks/>
          </p:cNvCxnSpPr>
          <p:nvPr/>
        </p:nvCxnSpPr>
        <p:spPr>
          <a:xfrm flipH="1">
            <a:off x="3914341" y="4019979"/>
            <a:ext cx="208397" cy="33321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58BCA6B-ECCA-FE4E-BC2B-4CE7208330E0}"/>
              </a:ext>
            </a:extLst>
          </p:cNvPr>
          <p:cNvSpPr txBox="1"/>
          <p:nvPr/>
        </p:nvSpPr>
        <p:spPr>
          <a:xfrm>
            <a:off x="4066134" y="3820279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C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AF51D9EE-1C4D-FA49-A5CC-0A572EA60B98}"/>
              </a:ext>
            </a:extLst>
          </p:cNvPr>
          <p:cNvCxnSpPr>
            <a:cxnSpLocks/>
          </p:cNvCxnSpPr>
          <p:nvPr/>
        </p:nvCxnSpPr>
        <p:spPr>
          <a:xfrm>
            <a:off x="4519982" y="3984112"/>
            <a:ext cx="265321" cy="35479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80F4AE15-096F-0241-9813-CFCD6677A43D}"/>
              </a:ext>
            </a:extLst>
          </p:cNvPr>
          <p:cNvCxnSpPr>
            <a:cxnSpLocks/>
          </p:cNvCxnSpPr>
          <p:nvPr/>
        </p:nvCxnSpPr>
        <p:spPr>
          <a:xfrm flipH="1">
            <a:off x="3878255" y="2629549"/>
            <a:ext cx="208397" cy="33321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3F79502-8E46-4A46-81C1-B5361E8A9160}"/>
              </a:ext>
            </a:extLst>
          </p:cNvPr>
          <p:cNvSpPr txBox="1"/>
          <p:nvPr/>
        </p:nvSpPr>
        <p:spPr>
          <a:xfrm>
            <a:off x="4030048" y="2429849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C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2D9396A9-CE1E-5946-8886-CA5054BC93B6}"/>
              </a:ext>
            </a:extLst>
          </p:cNvPr>
          <p:cNvCxnSpPr>
            <a:cxnSpLocks/>
          </p:cNvCxnSpPr>
          <p:nvPr/>
        </p:nvCxnSpPr>
        <p:spPr>
          <a:xfrm>
            <a:off x="4483896" y="2593682"/>
            <a:ext cx="117962" cy="35488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7C86B2E-F518-B440-B9BD-A22662BBAB79}"/>
              </a:ext>
            </a:extLst>
          </p:cNvPr>
          <p:cNvSpPr txBox="1"/>
          <p:nvPr/>
        </p:nvSpPr>
        <p:spPr>
          <a:xfrm>
            <a:off x="3192442" y="333545"/>
            <a:ext cx="5807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gimoto A</a:t>
            </a:r>
            <a:r>
              <a:rPr lang="en-US" altLang="ja-JP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t al.</a:t>
            </a:r>
            <a:endParaRPr kumimoji="1" lang="ja-JP" altLang="en-US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8217BA24-8533-6C4E-A8FF-560F5E314881}"/>
              </a:ext>
            </a:extLst>
          </p:cNvPr>
          <p:cNvCxnSpPr>
            <a:cxnSpLocks/>
          </p:cNvCxnSpPr>
          <p:nvPr/>
        </p:nvCxnSpPr>
        <p:spPr>
          <a:xfrm>
            <a:off x="1761818" y="1859546"/>
            <a:ext cx="324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3B2F245-B43F-412A-8F7E-2AA5B43E8514}"/>
              </a:ext>
            </a:extLst>
          </p:cNvPr>
          <p:cNvSpPr txBox="1"/>
          <p:nvPr/>
        </p:nvSpPr>
        <p:spPr>
          <a:xfrm>
            <a:off x="746404" y="1309792"/>
            <a:ext cx="313935" cy="369332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74F6155-EF1D-4DE2-8558-BF1F4851897B}"/>
              </a:ext>
            </a:extLst>
          </p:cNvPr>
          <p:cNvSpPr txBox="1"/>
          <p:nvPr/>
        </p:nvSpPr>
        <p:spPr>
          <a:xfrm>
            <a:off x="5726975" y="1309792"/>
            <a:ext cx="313935" cy="369332"/>
          </a:xfrm>
          <a:prstGeom prst="rect">
            <a:avLst/>
          </a:prstGeom>
          <a:noFill/>
          <a:ln>
            <a:solidFill>
              <a:schemeClr val="tx1">
                <a:lumMod val="85000"/>
                <a:lumOff val="1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7" name="図 96">
            <a:extLst>
              <a:ext uri="{FF2B5EF4-FFF2-40B4-BE49-F238E27FC236}">
                <a16:creationId xmlns:a16="http://schemas.microsoft.com/office/drawing/2014/main" id="{207C8BFC-5D5F-A349-8485-EC70BE62B74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036311" y="3551346"/>
            <a:ext cx="1800000" cy="1440001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E91DB23C-E5F0-8542-BC17-53F117029F1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email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049015" y="1984308"/>
            <a:ext cx="1800000" cy="1440000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DB1FA93B-773A-D34D-B94F-1EAD468D307D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email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049015" y="5149862"/>
            <a:ext cx="1800000" cy="1440000"/>
          </a:xfrm>
          <a:prstGeom prst="rect">
            <a:avLst/>
          </a:prstGeom>
        </p:spPr>
      </p:pic>
      <p:pic>
        <p:nvPicPr>
          <p:cNvPr id="100" name="図 99">
            <a:extLst>
              <a:ext uri="{FF2B5EF4-FFF2-40B4-BE49-F238E27FC236}">
                <a16:creationId xmlns:a16="http://schemas.microsoft.com/office/drawing/2014/main" id="{C3A75641-9F72-E843-A292-4E75CDA6827C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email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51600" y="3551345"/>
            <a:ext cx="1800000" cy="144000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A20F849E-5E02-164A-AB26-D4BD2B770188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email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4304" y="1984308"/>
            <a:ext cx="1800000" cy="144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ADCC98B0-1C81-5D44-AB60-EECE779C3075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email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4304" y="5149862"/>
            <a:ext cx="1800000" cy="144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2F565B1F-2216-D547-BAD8-3D8CC379C658}"/>
              </a:ext>
            </a:extLst>
          </p:cNvPr>
          <p:cNvSpPr txBox="1"/>
          <p:nvPr/>
        </p:nvSpPr>
        <p:spPr>
          <a:xfrm>
            <a:off x="5866134" y="4110974"/>
            <a:ext cx="1193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retinin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AE5147A6-658D-8842-A8AE-9EFFE6D68010}"/>
              </a:ext>
            </a:extLst>
          </p:cNvPr>
          <p:cNvSpPr txBox="1"/>
          <p:nvPr/>
        </p:nvSpPr>
        <p:spPr>
          <a:xfrm>
            <a:off x="6126942" y="2544335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CD566BEC-2A47-BC4F-88A9-156E274B331F}"/>
              </a:ext>
            </a:extLst>
          </p:cNvPr>
          <p:cNvSpPr txBox="1"/>
          <p:nvPr/>
        </p:nvSpPr>
        <p:spPr>
          <a:xfrm>
            <a:off x="6109316" y="5684188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&amp;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58F5B420-C96A-D540-876A-C20F59B2FC11}"/>
              </a:ext>
            </a:extLst>
          </p:cNvPr>
          <p:cNvSpPr txBox="1"/>
          <p:nvPr/>
        </p:nvSpPr>
        <p:spPr>
          <a:xfrm>
            <a:off x="7123882" y="2262934"/>
            <a:ext cx="900000" cy="720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0F50ACBB-CF2F-E048-A288-18CE30510A13}"/>
              </a:ext>
            </a:extLst>
          </p:cNvPr>
          <p:cNvSpPr txBox="1"/>
          <p:nvPr/>
        </p:nvSpPr>
        <p:spPr>
          <a:xfrm>
            <a:off x="7123882" y="3824519"/>
            <a:ext cx="900000" cy="720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A17FB620-986D-D14C-B58C-6086632DCB07}"/>
              </a:ext>
            </a:extLst>
          </p:cNvPr>
          <p:cNvSpPr txBox="1"/>
          <p:nvPr/>
        </p:nvSpPr>
        <p:spPr>
          <a:xfrm>
            <a:off x="7130375" y="5374255"/>
            <a:ext cx="900000" cy="720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cxnSp>
        <p:nvCxnSpPr>
          <p:cNvPr id="117" name="直線矢印コネクタ 116">
            <a:extLst>
              <a:ext uri="{FF2B5EF4-FFF2-40B4-BE49-F238E27FC236}">
                <a16:creationId xmlns:a16="http://schemas.microsoft.com/office/drawing/2014/main" id="{5CFC04C9-69A5-ED40-ACCF-8723757EE6ED}"/>
              </a:ext>
            </a:extLst>
          </p:cNvPr>
          <p:cNvCxnSpPr>
            <a:cxnSpLocks/>
          </p:cNvCxnSpPr>
          <p:nvPr/>
        </p:nvCxnSpPr>
        <p:spPr>
          <a:xfrm>
            <a:off x="8023882" y="2515494"/>
            <a:ext cx="900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矢印コネクタ 117">
            <a:extLst>
              <a:ext uri="{FF2B5EF4-FFF2-40B4-BE49-F238E27FC236}">
                <a16:creationId xmlns:a16="http://schemas.microsoft.com/office/drawing/2014/main" id="{39EFEEBA-969F-FF48-AC79-FC084DAADDF5}"/>
              </a:ext>
            </a:extLst>
          </p:cNvPr>
          <p:cNvCxnSpPr>
            <a:cxnSpLocks/>
          </p:cNvCxnSpPr>
          <p:nvPr/>
        </p:nvCxnSpPr>
        <p:spPr>
          <a:xfrm>
            <a:off x="8023882" y="4094031"/>
            <a:ext cx="900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矢印コネクタ 118">
            <a:extLst>
              <a:ext uri="{FF2B5EF4-FFF2-40B4-BE49-F238E27FC236}">
                <a16:creationId xmlns:a16="http://schemas.microsoft.com/office/drawing/2014/main" id="{C6061B76-742D-704E-AA34-575C8028FAF5}"/>
              </a:ext>
            </a:extLst>
          </p:cNvPr>
          <p:cNvCxnSpPr>
            <a:cxnSpLocks/>
          </p:cNvCxnSpPr>
          <p:nvPr/>
        </p:nvCxnSpPr>
        <p:spPr>
          <a:xfrm>
            <a:off x="8030375" y="5619383"/>
            <a:ext cx="900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矢印コネクタ 119">
            <a:extLst>
              <a:ext uri="{FF2B5EF4-FFF2-40B4-BE49-F238E27FC236}">
                <a16:creationId xmlns:a16="http://schemas.microsoft.com/office/drawing/2014/main" id="{C6E74C2D-8D73-884D-B0D5-C12640252A96}"/>
              </a:ext>
            </a:extLst>
          </p:cNvPr>
          <p:cNvCxnSpPr>
            <a:cxnSpLocks/>
          </p:cNvCxnSpPr>
          <p:nvPr/>
        </p:nvCxnSpPr>
        <p:spPr>
          <a:xfrm flipH="1">
            <a:off x="9268129" y="2485100"/>
            <a:ext cx="247003" cy="36378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C3F3C401-BD8D-7744-98E0-52D24B99B1D2}"/>
              </a:ext>
            </a:extLst>
          </p:cNvPr>
          <p:cNvSpPr txBox="1"/>
          <p:nvPr/>
        </p:nvSpPr>
        <p:spPr>
          <a:xfrm>
            <a:off x="9458527" y="2285400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C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2" name="直線矢印コネクタ 121">
            <a:extLst>
              <a:ext uri="{FF2B5EF4-FFF2-40B4-BE49-F238E27FC236}">
                <a16:creationId xmlns:a16="http://schemas.microsoft.com/office/drawing/2014/main" id="{6B9A250F-6AB6-994A-B79B-8D3034888424}"/>
              </a:ext>
            </a:extLst>
          </p:cNvPr>
          <p:cNvCxnSpPr>
            <a:cxnSpLocks/>
          </p:cNvCxnSpPr>
          <p:nvPr/>
        </p:nvCxnSpPr>
        <p:spPr>
          <a:xfrm>
            <a:off x="9912375" y="2449233"/>
            <a:ext cx="260246" cy="42250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矢印コネクタ 126">
            <a:extLst>
              <a:ext uri="{FF2B5EF4-FFF2-40B4-BE49-F238E27FC236}">
                <a16:creationId xmlns:a16="http://schemas.microsoft.com/office/drawing/2014/main" id="{517C2A97-05C2-E844-8225-DFA92D4EAAE2}"/>
              </a:ext>
            </a:extLst>
          </p:cNvPr>
          <p:cNvCxnSpPr>
            <a:cxnSpLocks/>
          </p:cNvCxnSpPr>
          <p:nvPr/>
        </p:nvCxnSpPr>
        <p:spPr>
          <a:xfrm flipH="1">
            <a:off x="9268129" y="4033675"/>
            <a:ext cx="247003" cy="36378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BB74FD18-9996-D54D-A427-8B795CA775F6}"/>
              </a:ext>
            </a:extLst>
          </p:cNvPr>
          <p:cNvSpPr txBox="1"/>
          <p:nvPr/>
        </p:nvSpPr>
        <p:spPr>
          <a:xfrm>
            <a:off x="9458527" y="3833975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C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9" name="直線矢印コネクタ 128">
            <a:extLst>
              <a:ext uri="{FF2B5EF4-FFF2-40B4-BE49-F238E27FC236}">
                <a16:creationId xmlns:a16="http://schemas.microsoft.com/office/drawing/2014/main" id="{AD8C8C37-F283-A845-AE3D-E16F617ACC08}"/>
              </a:ext>
            </a:extLst>
          </p:cNvPr>
          <p:cNvCxnSpPr>
            <a:cxnSpLocks/>
          </p:cNvCxnSpPr>
          <p:nvPr/>
        </p:nvCxnSpPr>
        <p:spPr>
          <a:xfrm>
            <a:off x="9912375" y="3997808"/>
            <a:ext cx="260246" cy="42250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矢印コネクタ 129">
            <a:extLst>
              <a:ext uri="{FF2B5EF4-FFF2-40B4-BE49-F238E27FC236}">
                <a16:creationId xmlns:a16="http://schemas.microsoft.com/office/drawing/2014/main" id="{054C112A-6BD3-CD49-8AFC-0B150D19EE21}"/>
              </a:ext>
            </a:extLst>
          </p:cNvPr>
          <p:cNvCxnSpPr>
            <a:cxnSpLocks/>
          </p:cNvCxnSpPr>
          <p:nvPr/>
        </p:nvCxnSpPr>
        <p:spPr>
          <a:xfrm flipH="1">
            <a:off x="9323125" y="5598132"/>
            <a:ext cx="192008" cy="48062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EB2A0959-DAAE-3146-8876-87D71DD3669A}"/>
              </a:ext>
            </a:extLst>
          </p:cNvPr>
          <p:cNvSpPr txBox="1"/>
          <p:nvPr/>
        </p:nvSpPr>
        <p:spPr>
          <a:xfrm>
            <a:off x="9458527" y="5398432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C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2" name="直線矢印コネクタ 131">
            <a:extLst>
              <a:ext uri="{FF2B5EF4-FFF2-40B4-BE49-F238E27FC236}">
                <a16:creationId xmlns:a16="http://schemas.microsoft.com/office/drawing/2014/main" id="{0BC9A1EA-18B3-CA40-A41C-9A386EB37138}"/>
              </a:ext>
            </a:extLst>
          </p:cNvPr>
          <p:cNvCxnSpPr>
            <a:cxnSpLocks/>
          </p:cNvCxnSpPr>
          <p:nvPr/>
        </p:nvCxnSpPr>
        <p:spPr>
          <a:xfrm>
            <a:off x="9912375" y="5562265"/>
            <a:ext cx="260246" cy="42250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F8242C26-BAC6-A84C-9E51-4D458FF2010C}"/>
              </a:ext>
            </a:extLst>
          </p:cNvPr>
          <p:cNvSpPr txBox="1"/>
          <p:nvPr/>
        </p:nvSpPr>
        <p:spPr>
          <a:xfrm>
            <a:off x="7329918" y="1497716"/>
            <a:ext cx="3153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toneum of Gastric Cancer</a:t>
            </a:r>
            <a:endParaRPr kumimoji="1"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直線矢印コネクタ 133">
            <a:extLst>
              <a:ext uri="{FF2B5EF4-FFF2-40B4-BE49-F238E27FC236}">
                <a16:creationId xmlns:a16="http://schemas.microsoft.com/office/drawing/2014/main" id="{5523EADA-AB99-0347-8611-B8614385CAA4}"/>
              </a:ext>
            </a:extLst>
          </p:cNvPr>
          <p:cNvCxnSpPr>
            <a:cxnSpLocks/>
          </p:cNvCxnSpPr>
          <p:nvPr/>
        </p:nvCxnSpPr>
        <p:spPr>
          <a:xfrm>
            <a:off x="7286630" y="1862804"/>
            <a:ext cx="324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2957BB7B-4C9D-4622-9EA1-A19FBF831E5C}"/>
              </a:ext>
            </a:extLst>
          </p:cNvPr>
          <p:cNvCxnSpPr>
            <a:cxnSpLocks/>
          </p:cNvCxnSpPr>
          <p:nvPr/>
        </p:nvCxnSpPr>
        <p:spPr>
          <a:xfrm>
            <a:off x="2567140" y="3251562"/>
            <a:ext cx="63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3B978618-CDD3-453D-BE7D-C3C21524764C}"/>
              </a:ext>
            </a:extLst>
          </p:cNvPr>
          <p:cNvCxnSpPr>
            <a:cxnSpLocks/>
          </p:cNvCxnSpPr>
          <p:nvPr/>
        </p:nvCxnSpPr>
        <p:spPr>
          <a:xfrm>
            <a:off x="3838338" y="3275312"/>
            <a:ext cx="12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BD0A1E54-28DC-4B37-8C4F-1B3CA06E31B3}"/>
              </a:ext>
            </a:extLst>
          </p:cNvPr>
          <p:cNvCxnSpPr>
            <a:cxnSpLocks/>
          </p:cNvCxnSpPr>
          <p:nvPr/>
        </p:nvCxnSpPr>
        <p:spPr>
          <a:xfrm>
            <a:off x="2562442" y="4923758"/>
            <a:ext cx="63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18B91790-2921-4119-9675-7643B74DDDDC}"/>
              </a:ext>
            </a:extLst>
          </p:cNvPr>
          <p:cNvCxnSpPr>
            <a:cxnSpLocks/>
          </p:cNvCxnSpPr>
          <p:nvPr/>
        </p:nvCxnSpPr>
        <p:spPr>
          <a:xfrm>
            <a:off x="3833640" y="4947508"/>
            <a:ext cx="12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12C3EF58-A2A9-4230-85BE-6A2C3B1B8386}"/>
              </a:ext>
            </a:extLst>
          </p:cNvPr>
          <p:cNvCxnSpPr>
            <a:cxnSpLocks/>
          </p:cNvCxnSpPr>
          <p:nvPr/>
        </p:nvCxnSpPr>
        <p:spPr>
          <a:xfrm>
            <a:off x="8100342" y="3275312"/>
            <a:ext cx="63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5CCB0359-4390-4F58-A4C1-0BBB5C3D162B}"/>
              </a:ext>
            </a:extLst>
          </p:cNvPr>
          <p:cNvCxnSpPr>
            <a:cxnSpLocks/>
          </p:cNvCxnSpPr>
          <p:nvPr/>
        </p:nvCxnSpPr>
        <p:spPr>
          <a:xfrm>
            <a:off x="9371540" y="3299062"/>
            <a:ext cx="12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DDDF58BA-180E-4C87-BCC8-B502192D0417}"/>
              </a:ext>
            </a:extLst>
          </p:cNvPr>
          <p:cNvCxnSpPr>
            <a:cxnSpLocks/>
          </p:cNvCxnSpPr>
          <p:nvPr/>
        </p:nvCxnSpPr>
        <p:spPr>
          <a:xfrm>
            <a:off x="8100342" y="4874359"/>
            <a:ext cx="63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F4205332-1723-4964-894C-FF5169745BF5}"/>
              </a:ext>
            </a:extLst>
          </p:cNvPr>
          <p:cNvCxnSpPr>
            <a:cxnSpLocks/>
          </p:cNvCxnSpPr>
          <p:nvPr/>
        </p:nvCxnSpPr>
        <p:spPr>
          <a:xfrm>
            <a:off x="9371540" y="4898109"/>
            <a:ext cx="12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126ACE8D-040F-453F-B595-7B4E59C09558}"/>
              </a:ext>
            </a:extLst>
          </p:cNvPr>
          <p:cNvCxnSpPr>
            <a:cxnSpLocks/>
          </p:cNvCxnSpPr>
          <p:nvPr/>
        </p:nvCxnSpPr>
        <p:spPr>
          <a:xfrm>
            <a:off x="8100342" y="6463523"/>
            <a:ext cx="63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81FEEDFF-61C7-48E9-A4C7-B7DFB1559F1F}"/>
              </a:ext>
            </a:extLst>
          </p:cNvPr>
          <p:cNvCxnSpPr>
            <a:cxnSpLocks/>
          </p:cNvCxnSpPr>
          <p:nvPr/>
        </p:nvCxnSpPr>
        <p:spPr>
          <a:xfrm>
            <a:off x="9371540" y="6487273"/>
            <a:ext cx="12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290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3</TotalTime>
  <Words>31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杉本　敦史</dc:creator>
  <cp:lastModifiedBy>chn off31</cp:lastModifiedBy>
  <cp:revision>113</cp:revision>
  <dcterms:created xsi:type="dcterms:W3CDTF">2020-12-10T23:24:33Z</dcterms:created>
  <dcterms:modified xsi:type="dcterms:W3CDTF">2021-07-06T03:32:34Z</dcterms:modified>
</cp:coreProperties>
</file>